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447" r:id="rId2"/>
    <p:sldId id="470" r:id="rId3"/>
    <p:sldId id="461" r:id="rId4"/>
    <p:sldId id="466" r:id="rId5"/>
    <p:sldId id="469" r:id="rId6"/>
    <p:sldId id="467" r:id="rId7"/>
    <p:sldId id="457" r:id="rId8"/>
    <p:sldId id="472" r:id="rId9"/>
    <p:sldId id="462" r:id="rId10"/>
    <p:sldId id="458" r:id="rId11"/>
    <p:sldId id="468" r:id="rId12"/>
    <p:sldId id="463" r:id="rId13"/>
    <p:sldId id="459" r:id="rId14"/>
    <p:sldId id="471" r:id="rId15"/>
    <p:sldId id="464" r:id="rId16"/>
    <p:sldId id="460" r:id="rId17"/>
    <p:sldId id="473" r:id="rId18"/>
    <p:sldId id="465" r:id="rId1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XRF" id="{37DCDD19-B2FB-4ED2-AD6B-92F0F39DDD48}">
          <p14:sldIdLst>
            <p14:sldId id="447"/>
            <p14:sldId id="470"/>
            <p14:sldId id="461"/>
            <p14:sldId id="466"/>
            <p14:sldId id="469"/>
            <p14:sldId id="467"/>
            <p14:sldId id="457"/>
            <p14:sldId id="472"/>
            <p14:sldId id="462"/>
            <p14:sldId id="458"/>
            <p14:sldId id="468"/>
            <p14:sldId id="463"/>
            <p14:sldId id="459"/>
            <p14:sldId id="471"/>
            <p14:sldId id="464"/>
            <p14:sldId id="460"/>
            <p14:sldId id="473"/>
            <p14:sldId id="465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6" autoAdjust="0"/>
    <p:restoredTop sz="94660"/>
  </p:normalViewPr>
  <p:slideViewPr>
    <p:cSldViewPr snapToGrid="0">
      <p:cViewPr varScale="1">
        <p:scale>
          <a:sx n="154" d="100"/>
          <a:sy n="154" d="100"/>
        </p:scale>
        <p:origin x="582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6BE215-0085-8E70-CFDE-E357CD86B8C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8944D89-D819-B724-C047-7149CA3683F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52589D-2809-C8F9-CEE9-D0C338EF62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7E036-4437-4A55-A5E6-37C5A44BC48B}" type="datetimeFigureOut">
              <a:rPr lang="en-US" smtClean="0"/>
              <a:t>8/1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E0CF88-9F54-D4B4-634C-AA2111471F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2E3449-059E-891E-3B2A-789FF1987C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BDBAB5-B0DD-455F-B249-B80BF81AD4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65937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B05158-DCB7-4471-F888-A458296C6F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8DEDB8F-B47B-2D13-9FAC-A1570451C2D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59C16C-510F-4BB7-0607-7EC11C3FCB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7E036-4437-4A55-A5E6-37C5A44BC48B}" type="datetimeFigureOut">
              <a:rPr lang="en-US" smtClean="0"/>
              <a:t>8/1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60A251-3F11-F6AE-74BC-3A295A8821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9AF2F5-70FD-E3BD-FCFF-CEC227626A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BDBAB5-B0DD-455F-B249-B80BF81AD4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53940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9BE9012-F2DD-C28B-F06C-01FBBEA329F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6D61EC8-9458-3AB3-CA02-42E462115F7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E9CFC8-EDA2-CD52-6BD3-F445B0B616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7E036-4437-4A55-A5E6-37C5A44BC48B}" type="datetimeFigureOut">
              <a:rPr lang="en-US" smtClean="0"/>
              <a:t>8/1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652445-59C0-9A8E-EAAA-58838C5AC1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A34543-3264-E2B1-0BAF-7AD53A27AA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BDBAB5-B0DD-455F-B249-B80BF81AD4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53403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28C665-3EFF-58BA-0663-D20C09DCAF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AF5773-8307-E65C-0EC5-8EBA365C15B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584C58-2A92-6436-29F9-D693FC8592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7E036-4437-4A55-A5E6-37C5A44BC48B}" type="datetimeFigureOut">
              <a:rPr lang="en-US" smtClean="0"/>
              <a:t>8/1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CF6A17-F7A6-3263-FEA8-B3340702B3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F0A250-A4D1-A784-BA6A-0FDB73679B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BDBAB5-B0DD-455F-B249-B80BF81AD4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90993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4536A0-67DE-9323-8B9A-3A62573BCB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C878DCB-B346-B955-4A86-24E41BC360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1F27DF-DD76-4CEF-8050-28343B026E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7E036-4437-4A55-A5E6-37C5A44BC48B}" type="datetimeFigureOut">
              <a:rPr lang="en-US" smtClean="0"/>
              <a:t>8/1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44EE7A-4B17-376C-F4A3-E49688D656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FCC99A-7A20-B7A3-2F77-8FEA3A7462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BDBAB5-B0DD-455F-B249-B80BF81AD4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88525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17E7D4-9ACB-173A-772C-A4BF1946B0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38B1E21-22E5-E98A-1DCD-5A308BCE2F8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85A32C5-1558-8899-85B8-5E6B4512729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6CAFAC4-58A9-6661-89AC-76309C7704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7E036-4437-4A55-A5E6-37C5A44BC48B}" type="datetimeFigureOut">
              <a:rPr lang="en-US" smtClean="0"/>
              <a:t>8/1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3A26D4C-4648-546A-986E-16598CCF3D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E9C872A-08F9-4C9C-F1B5-7F96D512EF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BDBAB5-B0DD-455F-B249-B80BF81AD4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43959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CDB07C-FC6E-73B3-EC0D-3693C70379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BD70CCC-779E-367E-4EF4-1251821756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C3BAA10-600D-5C90-65BF-C9998C79B19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E72822B-2933-CEC8-9847-10FA20217ED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0CB5650-767B-09DA-D329-70EC597D3C9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A1137C7-8591-FDB3-DFAC-48A3D33E40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7E036-4437-4A55-A5E6-37C5A44BC48B}" type="datetimeFigureOut">
              <a:rPr lang="en-US" smtClean="0"/>
              <a:t>8/13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99086DC-FB41-0A2A-2D12-EBE82B3A2C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DCCBCAD-2A7A-42A4-0A57-AC93B1E96C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BDBAB5-B0DD-455F-B249-B80BF81AD4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1791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48A5C5-F2CE-45DF-081A-2074CA264C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1928C17-FF52-1B2E-41D7-26369DE4E7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7E036-4437-4A55-A5E6-37C5A44BC48B}" type="datetimeFigureOut">
              <a:rPr lang="en-US" smtClean="0"/>
              <a:t>8/13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A0A07F5-EEAA-9D76-230A-B17264E119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1F6E517-0035-EE2C-7990-FD7FB1A658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BDBAB5-B0DD-455F-B249-B80BF81AD4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94742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C4588D5-009C-2C33-ADA6-FCC62D0E2D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7E036-4437-4A55-A5E6-37C5A44BC48B}" type="datetimeFigureOut">
              <a:rPr lang="en-US" smtClean="0"/>
              <a:t>8/13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A43BC49-B959-D57E-0DA5-409814E7EF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A15452D-EADA-FFEF-CD4E-D66ADEF495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BDBAB5-B0DD-455F-B249-B80BF81AD4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97716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DAA3A4-195F-17F7-D226-107547A58D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A5850FD-0FD2-21A6-9F6D-5629FC2B5BA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111E1E3-A105-9745-E20B-F7CB4E4DAC9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00F444B-39BD-DEE5-8ABC-A69BDA7064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7E036-4437-4A55-A5E6-37C5A44BC48B}" type="datetimeFigureOut">
              <a:rPr lang="en-US" smtClean="0"/>
              <a:t>8/1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B915033-E461-70BF-9A74-4119CD8464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D00A64D-4384-C408-B4B4-B19074579F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BDBAB5-B0DD-455F-B249-B80BF81AD4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31037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A853A2-CAE4-C6B4-3C04-CDE8C2C166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673C610-2DE8-6D81-C1F0-AF100E13626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A641E6F-BA6B-B142-F0DE-A92C2283C65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0FD90C9-5B0B-A4FC-8B8E-A62FD73395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7E036-4437-4A55-A5E6-37C5A44BC48B}" type="datetimeFigureOut">
              <a:rPr lang="en-US" smtClean="0"/>
              <a:t>8/1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341895F-5B43-B248-47B4-1107EB74DA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96E9960-76AE-1DD3-A748-BB09A080F8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BDBAB5-B0DD-455F-B249-B80BF81AD4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47296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14510B6-FA43-7165-4815-B0EE029769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0E8AA16-BA68-57F3-98CC-41147323E3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BA938D-0F18-D4B4-F8BF-9C8111D6C49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B87E036-4437-4A55-A5E6-37C5A44BC48B}" type="datetimeFigureOut">
              <a:rPr lang="en-US" smtClean="0"/>
              <a:t>8/1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AC34AA-8665-1379-F6B0-9C555B26A35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822D31A-5BD6-5525-9450-631E3A87BDA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EBDBAB5-B0DD-455F-B249-B80BF81AD4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02218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3.png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7.png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1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9AFD4BE-E413-7A47-25CC-7C3ACE1FA0D9}"/>
              </a:ext>
            </a:extLst>
          </p:cNvPr>
          <p:cNvSpPr txBox="1"/>
          <p:nvPr/>
        </p:nvSpPr>
        <p:spPr>
          <a:xfrm>
            <a:off x="426719" y="1674342"/>
            <a:ext cx="2429694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mage notes:</a:t>
            </a:r>
          </a:p>
          <a:p>
            <a:endParaRPr lang="en-US" dirty="0"/>
          </a:p>
          <a:p>
            <a:r>
              <a:rPr lang="en-US" dirty="0"/>
              <a:t>First image is the pre-set maximum.</a:t>
            </a:r>
          </a:p>
          <a:p>
            <a:r>
              <a:rPr lang="en-US" dirty="0"/>
              <a:t>Subsequent images are manually set to better show the element of interest.</a:t>
            </a:r>
          </a:p>
          <a:p>
            <a:endParaRPr lang="en-US" dirty="0"/>
          </a:p>
          <a:p>
            <a:r>
              <a:rPr lang="en-US" dirty="0"/>
              <a:t>Images have been cropped to exactly 5’x5’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55306FC4-FEFD-0210-62C2-786A01C51FA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646"/>
          <a:stretch/>
        </p:blipFill>
        <p:spPr>
          <a:xfrm>
            <a:off x="3809995" y="1629748"/>
            <a:ext cx="4572009" cy="4085256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46C231A0-960E-D110-6060-4EBD4984723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9354"/>
          <a:stretch/>
        </p:blipFill>
        <p:spPr>
          <a:xfrm>
            <a:off x="3495864" y="738669"/>
            <a:ext cx="4572009" cy="486752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763A8A24-9923-9441-2E49-BD07CA4389D1}"/>
              </a:ext>
            </a:extLst>
          </p:cNvPr>
          <p:cNvSpPr txBox="1"/>
          <p:nvPr/>
        </p:nvSpPr>
        <p:spPr>
          <a:xfrm>
            <a:off x="4426382" y="1457544"/>
            <a:ext cx="5124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Dabi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8411939-6827-AAEC-F845-AE0BFD99A633}"/>
              </a:ext>
            </a:extLst>
          </p:cNvPr>
          <p:cNvSpPr txBox="1"/>
          <p:nvPr/>
        </p:nvSpPr>
        <p:spPr>
          <a:xfrm>
            <a:off x="4942161" y="1457545"/>
            <a:ext cx="7464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442115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D7C4338-7714-2676-498B-F1FB626FF295}"/>
              </a:ext>
            </a:extLst>
          </p:cNvPr>
          <p:cNvSpPr txBox="1"/>
          <p:nvPr/>
        </p:nvSpPr>
        <p:spPr>
          <a:xfrm>
            <a:off x="5652966" y="1468263"/>
            <a:ext cx="7301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494293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BFD76D2-0008-C9E4-9444-8186103CAC30}"/>
              </a:ext>
            </a:extLst>
          </p:cNvPr>
          <p:cNvSpPr txBox="1"/>
          <p:nvPr/>
        </p:nvSpPr>
        <p:spPr>
          <a:xfrm>
            <a:off x="6362326" y="1483903"/>
            <a:ext cx="7315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524446</a:t>
            </a:r>
          </a:p>
        </p:txBody>
      </p:sp>
    </p:spTree>
    <p:extLst>
      <p:ext uri="{BB962C8B-B14F-4D97-AF65-F5344CB8AC3E}">
        <p14:creationId xmlns:p14="http://schemas.microsoft.com/office/powerpoint/2010/main" val="85518207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Picture 23">
            <a:extLst>
              <a:ext uri="{FF2B5EF4-FFF2-40B4-BE49-F238E27FC236}">
                <a16:creationId xmlns:a16="http://schemas.microsoft.com/office/drawing/2014/main" id="{E641DD47-EC12-13E2-49D6-9A25CE89109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782"/>
          <a:stretch/>
        </p:blipFill>
        <p:spPr>
          <a:xfrm>
            <a:off x="3809995" y="1635967"/>
            <a:ext cx="4572009" cy="407903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3040DF15-C8F2-8EFC-953B-662115412CA7}"/>
              </a:ext>
            </a:extLst>
          </p:cNvPr>
          <p:cNvSpPr txBox="1"/>
          <p:nvPr/>
        </p:nvSpPr>
        <p:spPr>
          <a:xfrm>
            <a:off x="4420329" y="1494621"/>
            <a:ext cx="5124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Dabi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90D3040-CF4E-FB12-3E51-D4F96AE5CE07}"/>
              </a:ext>
            </a:extLst>
          </p:cNvPr>
          <p:cNvSpPr txBox="1"/>
          <p:nvPr/>
        </p:nvSpPr>
        <p:spPr>
          <a:xfrm>
            <a:off x="4927298" y="1496344"/>
            <a:ext cx="7464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442115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F026DFA-0E53-B8C8-202B-A5EC278A5ACC}"/>
              </a:ext>
            </a:extLst>
          </p:cNvPr>
          <p:cNvSpPr txBox="1"/>
          <p:nvPr/>
        </p:nvSpPr>
        <p:spPr>
          <a:xfrm>
            <a:off x="5621363" y="1495918"/>
            <a:ext cx="7301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494293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7EEC2AF-2D7E-E849-DE78-46702623EECA}"/>
              </a:ext>
            </a:extLst>
          </p:cNvPr>
          <p:cNvSpPr txBox="1"/>
          <p:nvPr/>
        </p:nvSpPr>
        <p:spPr>
          <a:xfrm>
            <a:off x="6362326" y="1512856"/>
            <a:ext cx="7315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524446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056B8A99-B6E4-F90E-0E90-3D08EA2282F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8877"/>
          <a:stretch/>
        </p:blipFill>
        <p:spPr>
          <a:xfrm>
            <a:off x="3449743" y="479771"/>
            <a:ext cx="4572009" cy="5085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893749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>
            <a:extLst>
              <a:ext uri="{FF2B5EF4-FFF2-40B4-BE49-F238E27FC236}">
                <a16:creationId xmlns:a16="http://schemas.microsoft.com/office/drawing/2014/main" id="{42A4FC2C-047E-45A5-965D-8E1E3BF09BC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 bwMode="white">
          <a:xfrm>
            <a:off x="1524" y="0"/>
            <a:ext cx="12188952" cy="6858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8600CEB-5F74-020E-3080-6EDA0467E66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68" t="9936" r="9061"/>
          <a:stretch/>
        </p:blipFill>
        <p:spPr>
          <a:xfrm>
            <a:off x="1928326" y="665448"/>
            <a:ext cx="8951790" cy="612443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2C8FB1D-20AE-C20C-B58F-C32C2129F628}"/>
              </a:ext>
            </a:extLst>
          </p:cNvPr>
          <p:cNvSpPr txBox="1"/>
          <p:nvPr/>
        </p:nvSpPr>
        <p:spPr>
          <a:xfrm>
            <a:off x="3378225" y="308302"/>
            <a:ext cx="609708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rgbClr val="0070C0"/>
                </a:solidFill>
                <a:effectLst/>
                <a:highlight>
                  <a:srgbClr val="FFFFFF"/>
                </a:highlight>
                <a:latin typeface="PT Serif" panose="020A06030405050202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Mn concentration in area density (µg/cm</a:t>
            </a:r>
            <a:r>
              <a:rPr lang="en-US" sz="1800" baseline="30000" dirty="0">
                <a:solidFill>
                  <a:srgbClr val="0070C0"/>
                </a:solidFill>
                <a:effectLst/>
                <a:highlight>
                  <a:srgbClr val="FFFFFF"/>
                </a:highlight>
                <a:latin typeface="PT Serif" panose="020A06030405050202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2</a:t>
            </a:r>
            <a:r>
              <a:rPr lang="en-US" sz="1800" dirty="0">
                <a:solidFill>
                  <a:srgbClr val="0070C0"/>
                </a:solidFill>
                <a:effectLst/>
                <a:highlight>
                  <a:srgbClr val="FFFFFF"/>
                </a:highlight>
                <a:latin typeface="PT Serif" panose="020A06030405050202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6873367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Picture 25">
            <a:extLst>
              <a:ext uri="{FF2B5EF4-FFF2-40B4-BE49-F238E27FC236}">
                <a16:creationId xmlns:a16="http://schemas.microsoft.com/office/drawing/2014/main" id="{2E56C549-E8BB-462E-9B3D-893C63F5545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918"/>
          <a:stretch/>
        </p:blipFill>
        <p:spPr>
          <a:xfrm>
            <a:off x="6252483" y="1642188"/>
            <a:ext cx="4572009" cy="4072816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EE2005AF-C2FF-856B-4144-D74ABC302AD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918"/>
          <a:stretch/>
        </p:blipFill>
        <p:spPr>
          <a:xfrm>
            <a:off x="1680474" y="1642188"/>
            <a:ext cx="4572009" cy="4072815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7CCDA514-D25F-7FC4-9AC8-15D732D2079C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8877"/>
          <a:stretch/>
        </p:blipFill>
        <p:spPr>
          <a:xfrm>
            <a:off x="1418469" y="678931"/>
            <a:ext cx="4572009" cy="508524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2CA19A31-704D-FEF5-F57C-C95EC271B1D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8877"/>
          <a:stretch/>
        </p:blipFill>
        <p:spPr>
          <a:xfrm>
            <a:off x="5990478" y="669303"/>
            <a:ext cx="4572009" cy="50852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2970F30-35B4-849B-B78E-7A62D0D87FF3}"/>
              </a:ext>
            </a:extLst>
          </p:cNvPr>
          <p:cNvSpPr txBox="1"/>
          <p:nvPr/>
        </p:nvSpPr>
        <p:spPr>
          <a:xfrm>
            <a:off x="2230576" y="1455397"/>
            <a:ext cx="5124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Dabi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38592B4-13B4-BA2B-7EA5-C2DF96053671}"/>
              </a:ext>
            </a:extLst>
          </p:cNvPr>
          <p:cNvSpPr txBox="1"/>
          <p:nvPr/>
        </p:nvSpPr>
        <p:spPr>
          <a:xfrm>
            <a:off x="2696202" y="1455395"/>
            <a:ext cx="7464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442115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55781D8-495A-0AC2-18E6-FE067407F2C5}"/>
              </a:ext>
            </a:extLst>
          </p:cNvPr>
          <p:cNvSpPr txBox="1"/>
          <p:nvPr/>
        </p:nvSpPr>
        <p:spPr>
          <a:xfrm>
            <a:off x="3395821" y="1455396"/>
            <a:ext cx="7301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494293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7CB49DA-F449-F4A6-C8AD-925B3AAFE48E}"/>
              </a:ext>
            </a:extLst>
          </p:cNvPr>
          <p:cNvSpPr txBox="1"/>
          <p:nvPr/>
        </p:nvSpPr>
        <p:spPr>
          <a:xfrm>
            <a:off x="4166520" y="1455396"/>
            <a:ext cx="7315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524446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13AB482-0C6C-DDFD-61CC-0512158FAD02}"/>
              </a:ext>
            </a:extLst>
          </p:cNvPr>
          <p:cNvSpPr txBox="1"/>
          <p:nvPr/>
        </p:nvSpPr>
        <p:spPr>
          <a:xfrm>
            <a:off x="6870783" y="1486496"/>
            <a:ext cx="5124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Dabi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0FE384B-B44C-B6E5-92E5-11B5F0AF07E2}"/>
              </a:ext>
            </a:extLst>
          </p:cNvPr>
          <p:cNvSpPr txBox="1"/>
          <p:nvPr/>
        </p:nvSpPr>
        <p:spPr>
          <a:xfrm>
            <a:off x="7336409" y="1486494"/>
            <a:ext cx="7464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442115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CD2BE16-AA71-3803-730F-27D66052BC8E}"/>
              </a:ext>
            </a:extLst>
          </p:cNvPr>
          <p:cNvSpPr txBox="1"/>
          <p:nvPr/>
        </p:nvSpPr>
        <p:spPr>
          <a:xfrm>
            <a:off x="8036028" y="1486495"/>
            <a:ext cx="7301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494293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26D7BCE-E76F-9E64-21B4-933A618C9383}"/>
              </a:ext>
            </a:extLst>
          </p:cNvPr>
          <p:cNvSpPr txBox="1"/>
          <p:nvPr/>
        </p:nvSpPr>
        <p:spPr>
          <a:xfrm>
            <a:off x="8806727" y="1486495"/>
            <a:ext cx="7315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524446</a:t>
            </a:r>
          </a:p>
        </p:txBody>
      </p:sp>
    </p:spTree>
    <p:extLst>
      <p:ext uri="{BB962C8B-B14F-4D97-AF65-F5344CB8AC3E}">
        <p14:creationId xmlns:p14="http://schemas.microsoft.com/office/powerpoint/2010/main" val="274437099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Picture 17">
            <a:extLst>
              <a:ext uri="{FF2B5EF4-FFF2-40B4-BE49-F238E27FC236}">
                <a16:creationId xmlns:a16="http://schemas.microsoft.com/office/drawing/2014/main" id="{D061F6BD-7751-D07D-9D52-3223BD45411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206"/>
          <a:stretch/>
        </p:blipFill>
        <p:spPr>
          <a:xfrm>
            <a:off x="4291983" y="1231641"/>
            <a:ext cx="4572009" cy="405966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A303774A-9CB5-BA69-603E-C41117B9005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8862"/>
          <a:stretch/>
        </p:blipFill>
        <p:spPr>
          <a:xfrm>
            <a:off x="3934300" y="299414"/>
            <a:ext cx="4572009" cy="509239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46583F32-292A-3460-17F6-CA7F8F6C7DF7}"/>
              </a:ext>
            </a:extLst>
          </p:cNvPr>
          <p:cNvSpPr txBox="1"/>
          <p:nvPr/>
        </p:nvSpPr>
        <p:spPr>
          <a:xfrm>
            <a:off x="4889800" y="1054181"/>
            <a:ext cx="5124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Dabi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19F8E53-EFA9-5A3B-2738-4E57054A50DE}"/>
              </a:ext>
            </a:extLst>
          </p:cNvPr>
          <p:cNvSpPr txBox="1"/>
          <p:nvPr/>
        </p:nvSpPr>
        <p:spPr>
          <a:xfrm>
            <a:off x="5355426" y="1054179"/>
            <a:ext cx="7464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442115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CEAC1C6-1686-546A-310B-DB9DD0B81F84}"/>
              </a:ext>
            </a:extLst>
          </p:cNvPr>
          <p:cNvSpPr txBox="1"/>
          <p:nvPr/>
        </p:nvSpPr>
        <p:spPr>
          <a:xfrm>
            <a:off x="6055045" y="1054180"/>
            <a:ext cx="7301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494293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DDC5FF5-FF8F-94F0-FA25-4EEE4632AFEF}"/>
              </a:ext>
            </a:extLst>
          </p:cNvPr>
          <p:cNvSpPr txBox="1"/>
          <p:nvPr/>
        </p:nvSpPr>
        <p:spPr>
          <a:xfrm>
            <a:off x="6825744" y="1054180"/>
            <a:ext cx="7315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524446</a:t>
            </a:r>
          </a:p>
        </p:txBody>
      </p:sp>
    </p:spTree>
    <p:extLst>
      <p:ext uri="{BB962C8B-B14F-4D97-AF65-F5344CB8AC3E}">
        <p14:creationId xmlns:p14="http://schemas.microsoft.com/office/powerpoint/2010/main" val="6045261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9F401BD-FF2D-0004-A291-F7598176BB75}"/>
              </a:ext>
            </a:extLst>
          </p:cNvPr>
          <p:cNvSpPr txBox="1"/>
          <p:nvPr/>
        </p:nvSpPr>
        <p:spPr>
          <a:xfrm>
            <a:off x="3378225" y="308302"/>
            <a:ext cx="609708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rgbClr val="0070C0"/>
                </a:solidFill>
                <a:effectLst/>
                <a:highlight>
                  <a:srgbClr val="FFFFFF"/>
                </a:highlight>
                <a:latin typeface="PT Serif" panose="020A06030405050202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K concentration in area density (µg/cm</a:t>
            </a:r>
            <a:r>
              <a:rPr lang="en-US" sz="1800" baseline="30000" dirty="0">
                <a:solidFill>
                  <a:srgbClr val="0070C0"/>
                </a:solidFill>
                <a:effectLst/>
                <a:highlight>
                  <a:srgbClr val="FFFFFF"/>
                </a:highlight>
                <a:latin typeface="PT Serif" panose="020A06030405050202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2</a:t>
            </a:r>
            <a:r>
              <a:rPr lang="en-US" sz="1800" dirty="0">
                <a:solidFill>
                  <a:srgbClr val="0070C0"/>
                </a:solidFill>
                <a:effectLst/>
                <a:highlight>
                  <a:srgbClr val="FFFFFF"/>
                </a:highlight>
                <a:latin typeface="PT Serif" panose="020A06030405050202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)</a:t>
            </a:r>
            <a:endParaRPr lang="en-US" dirty="0"/>
          </a:p>
        </p:txBody>
      </p:sp>
      <p:pic>
        <p:nvPicPr>
          <p:cNvPr id="6" name="Picture 5" descr="A graph of different colored objects&#10;&#10;Description automatically generated">
            <a:extLst>
              <a:ext uri="{FF2B5EF4-FFF2-40B4-BE49-F238E27FC236}">
                <a16:creationId xmlns:a16="http://schemas.microsoft.com/office/drawing/2014/main" id="{1FD0778A-A229-ED84-92B8-B89F6522C51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885" r="9305"/>
          <a:stretch/>
        </p:blipFill>
        <p:spPr>
          <a:xfrm>
            <a:off x="952500" y="746448"/>
            <a:ext cx="9329835" cy="61115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0463982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Picture 19">
            <a:extLst>
              <a:ext uri="{FF2B5EF4-FFF2-40B4-BE49-F238E27FC236}">
                <a16:creationId xmlns:a16="http://schemas.microsoft.com/office/drawing/2014/main" id="{4139A285-8AE4-5D38-665F-17C79FBB7A6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642"/>
          <a:stretch/>
        </p:blipFill>
        <p:spPr>
          <a:xfrm>
            <a:off x="6096000" y="1785257"/>
            <a:ext cx="4572009" cy="4085439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0C1A10AB-F8E6-2DDC-CE0C-3F0FF4AE021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642"/>
          <a:stretch/>
        </p:blipFill>
        <p:spPr>
          <a:xfrm>
            <a:off x="1523991" y="1785257"/>
            <a:ext cx="4572009" cy="4085439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1289EAC8-CA69-0050-C845-EEBA4F6320A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8862"/>
          <a:stretch/>
        </p:blipFill>
        <p:spPr>
          <a:xfrm>
            <a:off x="1278186" y="875038"/>
            <a:ext cx="4572009" cy="509239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F57D8B87-1C52-5E5C-F821-E2288A6FA882}"/>
              </a:ext>
            </a:extLst>
          </p:cNvPr>
          <p:cNvSpPr txBox="1"/>
          <p:nvPr/>
        </p:nvSpPr>
        <p:spPr>
          <a:xfrm>
            <a:off x="2071955" y="1638899"/>
            <a:ext cx="5124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Dabi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8D7B98C-8034-D98B-86EC-19A6494069F6}"/>
              </a:ext>
            </a:extLst>
          </p:cNvPr>
          <p:cNvSpPr txBox="1"/>
          <p:nvPr/>
        </p:nvSpPr>
        <p:spPr>
          <a:xfrm>
            <a:off x="2537581" y="1638897"/>
            <a:ext cx="7464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442115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9D73151-F359-C345-9B6A-B7A019F96649}"/>
              </a:ext>
            </a:extLst>
          </p:cNvPr>
          <p:cNvSpPr txBox="1"/>
          <p:nvPr/>
        </p:nvSpPr>
        <p:spPr>
          <a:xfrm>
            <a:off x="3237200" y="1638898"/>
            <a:ext cx="7301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494293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30068D5-108F-AD2C-5475-AFBF608C17EF}"/>
              </a:ext>
            </a:extLst>
          </p:cNvPr>
          <p:cNvSpPr txBox="1"/>
          <p:nvPr/>
        </p:nvSpPr>
        <p:spPr>
          <a:xfrm>
            <a:off x="4007899" y="1638898"/>
            <a:ext cx="7315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524446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DA1D5EA-D869-CA3D-3FD1-7C7C21F95AAC}"/>
              </a:ext>
            </a:extLst>
          </p:cNvPr>
          <p:cNvSpPr txBox="1"/>
          <p:nvPr/>
        </p:nvSpPr>
        <p:spPr>
          <a:xfrm>
            <a:off x="6791286" y="1638897"/>
            <a:ext cx="5124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Dabi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ED76EB6-20F2-41F4-D663-01D82FD03CBE}"/>
              </a:ext>
            </a:extLst>
          </p:cNvPr>
          <p:cNvSpPr txBox="1"/>
          <p:nvPr/>
        </p:nvSpPr>
        <p:spPr>
          <a:xfrm>
            <a:off x="7256912" y="1638895"/>
            <a:ext cx="7464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442115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C175E05-7B91-0643-0D9A-BE4FEEF526AD}"/>
              </a:ext>
            </a:extLst>
          </p:cNvPr>
          <p:cNvSpPr txBox="1"/>
          <p:nvPr/>
        </p:nvSpPr>
        <p:spPr>
          <a:xfrm>
            <a:off x="7956531" y="1638896"/>
            <a:ext cx="7301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494293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709AC21-1EA0-5F1B-4065-BF2E036AC5C2}"/>
              </a:ext>
            </a:extLst>
          </p:cNvPr>
          <p:cNvSpPr txBox="1"/>
          <p:nvPr/>
        </p:nvSpPr>
        <p:spPr>
          <a:xfrm>
            <a:off x="8727230" y="1638896"/>
            <a:ext cx="7315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524446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15C0804C-F217-66DE-31A2-413AA9F7CC6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8862"/>
          <a:stretch/>
        </p:blipFill>
        <p:spPr>
          <a:xfrm>
            <a:off x="5850195" y="1075528"/>
            <a:ext cx="4572009" cy="5092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08773353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>
            <a:extLst>
              <a:ext uri="{FF2B5EF4-FFF2-40B4-BE49-F238E27FC236}">
                <a16:creationId xmlns:a16="http://schemas.microsoft.com/office/drawing/2014/main" id="{E057CAAD-F092-D875-FDBD-9053BFEFA90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327"/>
          <a:stretch/>
        </p:blipFill>
        <p:spPr>
          <a:xfrm>
            <a:off x="3809995" y="1660849"/>
            <a:ext cx="4572009" cy="4054155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2A5FB222-8A27-55D1-0241-EFF80F5BA569}"/>
              </a:ext>
            </a:extLst>
          </p:cNvPr>
          <p:cNvSpPr txBox="1"/>
          <p:nvPr/>
        </p:nvSpPr>
        <p:spPr>
          <a:xfrm>
            <a:off x="4392168" y="1489610"/>
            <a:ext cx="5124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Dabi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EEBD8ED-5C3D-4A54-C89D-A051F50D2E36}"/>
              </a:ext>
            </a:extLst>
          </p:cNvPr>
          <p:cNvSpPr txBox="1"/>
          <p:nvPr/>
        </p:nvSpPr>
        <p:spPr>
          <a:xfrm>
            <a:off x="4857794" y="1489608"/>
            <a:ext cx="7464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442115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89F3C81-B7F4-6C6E-283F-3E725707588E}"/>
              </a:ext>
            </a:extLst>
          </p:cNvPr>
          <p:cNvSpPr txBox="1"/>
          <p:nvPr/>
        </p:nvSpPr>
        <p:spPr>
          <a:xfrm>
            <a:off x="5557413" y="1489609"/>
            <a:ext cx="7301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494293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4F1EFE5-5D21-2DED-2B9D-71B41E8BBD41}"/>
              </a:ext>
            </a:extLst>
          </p:cNvPr>
          <p:cNvSpPr txBox="1"/>
          <p:nvPr/>
        </p:nvSpPr>
        <p:spPr>
          <a:xfrm>
            <a:off x="6328112" y="1489609"/>
            <a:ext cx="7315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524446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7EA1B048-A5E1-7EE7-F209-336B85F7083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8945"/>
          <a:stretch/>
        </p:blipFill>
        <p:spPr>
          <a:xfrm>
            <a:off x="3558069" y="817108"/>
            <a:ext cx="4572009" cy="5054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9512419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of different colored objects&#10;&#10;Description automatically generated">
            <a:extLst>
              <a:ext uri="{FF2B5EF4-FFF2-40B4-BE49-F238E27FC236}">
                <a16:creationId xmlns:a16="http://schemas.microsoft.com/office/drawing/2014/main" id="{5650CD17-7632-9B8A-1DC0-B79C062EE37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76" t="9142" r="8942"/>
          <a:stretch/>
        </p:blipFill>
        <p:spPr>
          <a:xfrm>
            <a:off x="1632857" y="807710"/>
            <a:ext cx="8569235" cy="591966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7EF152A-3CA0-84AE-2155-FE77EC6AB4C4}"/>
              </a:ext>
            </a:extLst>
          </p:cNvPr>
          <p:cNvSpPr txBox="1"/>
          <p:nvPr/>
        </p:nvSpPr>
        <p:spPr>
          <a:xfrm>
            <a:off x="3378225" y="308302"/>
            <a:ext cx="609708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rgbClr val="0070C0"/>
                </a:solidFill>
                <a:effectLst/>
                <a:highlight>
                  <a:srgbClr val="FFFFFF"/>
                </a:highlight>
                <a:latin typeface="PT Serif" panose="020A06030405050202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Fe concentration in area density (µg/cm</a:t>
            </a:r>
            <a:r>
              <a:rPr lang="en-US" sz="1800" baseline="30000" dirty="0">
                <a:solidFill>
                  <a:srgbClr val="0070C0"/>
                </a:solidFill>
                <a:effectLst/>
                <a:highlight>
                  <a:srgbClr val="FFFFFF"/>
                </a:highlight>
                <a:latin typeface="PT Serif" panose="020A06030405050202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2</a:t>
            </a:r>
            <a:r>
              <a:rPr lang="en-US" sz="1800" dirty="0">
                <a:solidFill>
                  <a:srgbClr val="0070C0"/>
                </a:solidFill>
                <a:effectLst/>
                <a:highlight>
                  <a:srgbClr val="FFFFFF"/>
                </a:highlight>
                <a:latin typeface="PT Serif" panose="020A06030405050202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70963778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>
            <a:extLst>
              <a:ext uri="{FF2B5EF4-FFF2-40B4-BE49-F238E27FC236}">
                <a16:creationId xmlns:a16="http://schemas.microsoft.com/office/drawing/2014/main" id="{F1CC89DE-DC0B-8E40-E2CE-9032B4DB134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918"/>
          <a:stretch/>
        </p:blipFill>
        <p:spPr>
          <a:xfrm>
            <a:off x="6221378" y="1642188"/>
            <a:ext cx="4572009" cy="4072816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F12BD03D-A753-38C2-4EBE-324B0E84567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918"/>
          <a:stretch/>
        </p:blipFill>
        <p:spPr>
          <a:xfrm>
            <a:off x="1649369" y="1642188"/>
            <a:ext cx="4572009" cy="4072815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D6FF81D-021D-F274-0BC6-5DB7322A3721}"/>
              </a:ext>
            </a:extLst>
          </p:cNvPr>
          <p:cNvSpPr txBox="1"/>
          <p:nvPr/>
        </p:nvSpPr>
        <p:spPr>
          <a:xfrm>
            <a:off x="2258568" y="1477169"/>
            <a:ext cx="5124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Dabi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EF45633-D772-0F85-DD7F-28FD3F01C709}"/>
              </a:ext>
            </a:extLst>
          </p:cNvPr>
          <p:cNvSpPr txBox="1"/>
          <p:nvPr/>
        </p:nvSpPr>
        <p:spPr>
          <a:xfrm>
            <a:off x="2724194" y="1477167"/>
            <a:ext cx="7464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442115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157BDBC-AE8E-C052-75A1-9F0EDB7DC320}"/>
              </a:ext>
            </a:extLst>
          </p:cNvPr>
          <p:cNvSpPr txBox="1"/>
          <p:nvPr/>
        </p:nvSpPr>
        <p:spPr>
          <a:xfrm>
            <a:off x="3423813" y="1477168"/>
            <a:ext cx="7301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494293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578342B-EF1A-A190-E668-35849D756C88}"/>
              </a:ext>
            </a:extLst>
          </p:cNvPr>
          <p:cNvSpPr txBox="1"/>
          <p:nvPr/>
        </p:nvSpPr>
        <p:spPr>
          <a:xfrm>
            <a:off x="4194512" y="1477168"/>
            <a:ext cx="7315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524446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A5F63E92-2D17-AF49-4E41-15AA412F43B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8945"/>
          <a:stretch/>
        </p:blipFill>
        <p:spPr>
          <a:xfrm>
            <a:off x="1424469" y="804667"/>
            <a:ext cx="4572009" cy="505414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04F7F68D-155E-9D9C-1D6F-3E9B80E9197F}"/>
              </a:ext>
            </a:extLst>
          </p:cNvPr>
          <p:cNvSpPr txBox="1"/>
          <p:nvPr/>
        </p:nvSpPr>
        <p:spPr>
          <a:xfrm>
            <a:off x="6804721" y="1466960"/>
            <a:ext cx="5124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Dabi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C27F30D-6CDA-D65F-2AB3-B7BD1252407D}"/>
              </a:ext>
            </a:extLst>
          </p:cNvPr>
          <p:cNvSpPr txBox="1"/>
          <p:nvPr/>
        </p:nvSpPr>
        <p:spPr>
          <a:xfrm>
            <a:off x="7270347" y="1466958"/>
            <a:ext cx="7464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442115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DF706CA-23FB-4EE1-0CBD-82250B0CAA5D}"/>
              </a:ext>
            </a:extLst>
          </p:cNvPr>
          <p:cNvSpPr txBox="1"/>
          <p:nvPr/>
        </p:nvSpPr>
        <p:spPr>
          <a:xfrm>
            <a:off x="7969966" y="1466959"/>
            <a:ext cx="7301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494293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505ECC3-A82B-48AD-236D-A53F3B55701D}"/>
              </a:ext>
            </a:extLst>
          </p:cNvPr>
          <p:cNvSpPr txBox="1"/>
          <p:nvPr/>
        </p:nvSpPr>
        <p:spPr>
          <a:xfrm>
            <a:off x="8740665" y="1466959"/>
            <a:ext cx="7315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524446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22FF6A1B-F695-19A6-C43E-811D105FF99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8945"/>
          <a:stretch/>
        </p:blipFill>
        <p:spPr>
          <a:xfrm>
            <a:off x="5996478" y="873929"/>
            <a:ext cx="4572009" cy="5054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71508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of different colored objects&#10;&#10;Description automatically generated">
            <a:extLst>
              <a:ext uri="{FF2B5EF4-FFF2-40B4-BE49-F238E27FC236}">
                <a16:creationId xmlns:a16="http://schemas.microsoft.com/office/drawing/2014/main" id="{D2DB6CAC-2DE6-1AB5-A4AF-21BB435B1E3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524" r="9132"/>
          <a:stretch/>
        </p:blipFill>
        <p:spPr>
          <a:xfrm>
            <a:off x="1507671" y="806292"/>
            <a:ext cx="8851175" cy="587535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C2F588A-DBA2-FBD5-96CB-54321D1C8C56}"/>
              </a:ext>
            </a:extLst>
          </p:cNvPr>
          <p:cNvSpPr txBox="1"/>
          <p:nvPr/>
        </p:nvSpPr>
        <p:spPr>
          <a:xfrm>
            <a:off x="3378225" y="308302"/>
            <a:ext cx="609708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rgbClr val="0070C0"/>
                </a:solidFill>
                <a:effectLst/>
                <a:highlight>
                  <a:srgbClr val="FFFFFF"/>
                </a:highlight>
                <a:latin typeface="PT Serif" panose="020A06030405050202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Ca concentration in area density (µg/cm</a:t>
            </a:r>
            <a:r>
              <a:rPr lang="en-US" sz="1800" baseline="30000" dirty="0">
                <a:solidFill>
                  <a:srgbClr val="0070C0"/>
                </a:solidFill>
                <a:effectLst/>
                <a:highlight>
                  <a:srgbClr val="FFFFFF"/>
                </a:highlight>
                <a:latin typeface="PT Serif" panose="020A06030405050202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2</a:t>
            </a:r>
            <a:r>
              <a:rPr lang="en-US" sz="1800" dirty="0">
                <a:solidFill>
                  <a:srgbClr val="0070C0"/>
                </a:solidFill>
                <a:effectLst/>
                <a:highlight>
                  <a:srgbClr val="FFFFFF"/>
                </a:highlight>
                <a:latin typeface="PT Serif" panose="020A06030405050202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190752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53E7D04C-CD34-B379-5BD8-A30DDBB9B8B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782"/>
          <a:stretch/>
        </p:blipFill>
        <p:spPr>
          <a:xfrm>
            <a:off x="6096000" y="1635967"/>
            <a:ext cx="4572009" cy="4079037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CE5AAFCB-A482-653E-6A88-7DBD50E33B5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782"/>
          <a:stretch/>
        </p:blipFill>
        <p:spPr>
          <a:xfrm>
            <a:off x="1523991" y="1635967"/>
            <a:ext cx="4572009" cy="407903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1DAB106C-C39F-6778-13EE-4C7B41EEF6D2}"/>
              </a:ext>
            </a:extLst>
          </p:cNvPr>
          <p:cNvSpPr txBox="1"/>
          <p:nvPr/>
        </p:nvSpPr>
        <p:spPr>
          <a:xfrm>
            <a:off x="2219237" y="5450548"/>
            <a:ext cx="5124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Dabi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63417E6-3700-3409-E313-11FF0F347C20}"/>
              </a:ext>
            </a:extLst>
          </p:cNvPr>
          <p:cNvSpPr txBox="1"/>
          <p:nvPr/>
        </p:nvSpPr>
        <p:spPr>
          <a:xfrm>
            <a:off x="2726206" y="5452271"/>
            <a:ext cx="7464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442115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8D92540-2100-8220-3B56-66A9ED948A09}"/>
              </a:ext>
            </a:extLst>
          </p:cNvPr>
          <p:cNvSpPr txBox="1"/>
          <p:nvPr/>
        </p:nvSpPr>
        <p:spPr>
          <a:xfrm>
            <a:off x="3420271" y="5451845"/>
            <a:ext cx="7301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494293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7278241-8C64-C734-C3B7-50B18CC7D94A}"/>
              </a:ext>
            </a:extLst>
          </p:cNvPr>
          <p:cNvSpPr txBox="1"/>
          <p:nvPr/>
        </p:nvSpPr>
        <p:spPr>
          <a:xfrm>
            <a:off x="4161234" y="5468783"/>
            <a:ext cx="7315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524446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2FB02AF5-E655-687D-7072-4B36D0A2BA4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9354"/>
          <a:stretch/>
        </p:blipFill>
        <p:spPr>
          <a:xfrm>
            <a:off x="1262737" y="732448"/>
            <a:ext cx="4572009" cy="486752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AF69683A-8FC5-58A3-804C-8595FBAA00B0}"/>
              </a:ext>
            </a:extLst>
          </p:cNvPr>
          <p:cNvSpPr txBox="1"/>
          <p:nvPr/>
        </p:nvSpPr>
        <p:spPr>
          <a:xfrm>
            <a:off x="2193255" y="1451323"/>
            <a:ext cx="5124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Dabi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5C50FEA-6CAA-4973-2744-D74BA9FE05A3}"/>
              </a:ext>
            </a:extLst>
          </p:cNvPr>
          <p:cNvSpPr txBox="1"/>
          <p:nvPr/>
        </p:nvSpPr>
        <p:spPr>
          <a:xfrm>
            <a:off x="2709034" y="1451324"/>
            <a:ext cx="7464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442115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85A8E02-B228-1895-B6B0-F50F6AE18D90}"/>
              </a:ext>
            </a:extLst>
          </p:cNvPr>
          <p:cNvSpPr txBox="1"/>
          <p:nvPr/>
        </p:nvSpPr>
        <p:spPr>
          <a:xfrm>
            <a:off x="3419839" y="1462042"/>
            <a:ext cx="7301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494293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31B0AC8-41BB-8BAF-F85D-16975EC7B94D}"/>
              </a:ext>
            </a:extLst>
          </p:cNvPr>
          <p:cNvSpPr txBox="1"/>
          <p:nvPr/>
        </p:nvSpPr>
        <p:spPr>
          <a:xfrm>
            <a:off x="4129199" y="1477682"/>
            <a:ext cx="7315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524446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338590C-1CBB-2639-435C-7E086902043E}"/>
              </a:ext>
            </a:extLst>
          </p:cNvPr>
          <p:cNvSpPr txBox="1"/>
          <p:nvPr/>
        </p:nvSpPr>
        <p:spPr>
          <a:xfrm>
            <a:off x="6668839" y="1451323"/>
            <a:ext cx="5124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Dabi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20C0B6C-0D0C-F73E-C862-6B93F8DC6FEF}"/>
              </a:ext>
            </a:extLst>
          </p:cNvPr>
          <p:cNvSpPr txBox="1"/>
          <p:nvPr/>
        </p:nvSpPr>
        <p:spPr>
          <a:xfrm>
            <a:off x="7184618" y="1451324"/>
            <a:ext cx="7464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442115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4E08FE0-483F-1533-B251-54BD5A423C5B}"/>
              </a:ext>
            </a:extLst>
          </p:cNvPr>
          <p:cNvSpPr txBox="1"/>
          <p:nvPr/>
        </p:nvSpPr>
        <p:spPr>
          <a:xfrm>
            <a:off x="7895423" y="1462042"/>
            <a:ext cx="7301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494293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70E1EC9-E088-5A96-E852-C336D2B27F4C}"/>
              </a:ext>
            </a:extLst>
          </p:cNvPr>
          <p:cNvSpPr txBox="1"/>
          <p:nvPr/>
        </p:nvSpPr>
        <p:spPr>
          <a:xfrm>
            <a:off x="8604783" y="1477682"/>
            <a:ext cx="7315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524446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1BF7A176-0FD7-D9F4-EFB8-CA0ADC41725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9354"/>
          <a:stretch/>
        </p:blipFill>
        <p:spPr>
          <a:xfrm>
            <a:off x="5834746" y="782547"/>
            <a:ext cx="4572009" cy="4867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508858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hart of a graph&#10;&#10;Description automatically generated with medium confidence">
            <a:extLst>
              <a:ext uri="{FF2B5EF4-FFF2-40B4-BE49-F238E27FC236}">
                <a16:creationId xmlns:a16="http://schemas.microsoft.com/office/drawing/2014/main" id="{5B523948-D1AF-F4BD-26F3-C53A7E9587F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646"/>
          <a:stretch/>
        </p:blipFill>
        <p:spPr>
          <a:xfrm>
            <a:off x="3809995" y="1542661"/>
            <a:ext cx="4572009" cy="408525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DC87DEB0-1087-88CA-7452-AF5929A7DD32}"/>
              </a:ext>
            </a:extLst>
          </p:cNvPr>
          <p:cNvSpPr txBox="1"/>
          <p:nvPr/>
        </p:nvSpPr>
        <p:spPr>
          <a:xfrm>
            <a:off x="4432602" y="1393191"/>
            <a:ext cx="5124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Dabi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0A77061-346D-C6A8-5F32-6126B8DE546E}"/>
              </a:ext>
            </a:extLst>
          </p:cNvPr>
          <p:cNvSpPr txBox="1"/>
          <p:nvPr/>
        </p:nvSpPr>
        <p:spPr>
          <a:xfrm>
            <a:off x="4948381" y="1393192"/>
            <a:ext cx="7464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442115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56312E7-F746-9371-9434-DB5C312925F1}"/>
              </a:ext>
            </a:extLst>
          </p:cNvPr>
          <p:cNvSpPr txBox="1"/>
          <p:nvPr/>
        </p:nvSpPr>
        <p:spPr>
          <a:xfrm>
            <a:off x="5659186" y="1403910"/>
            <a:ext cx="7301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494293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1842933-3A0A-CA70-AB39-FE021D103CAE}"/>
              </a:ext>
            </a:extLst>
          </p:cNvPr>
          <p:cNvSpPr txBox="1"/>
          <p:nvPr/>
        </p:nvSpPr>
        <p:spPr>
          <a:xfrm>
            <a:off x="6368546" y="1419550"/>
            <a:ext cx="7315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524446</a:t>
            </a:r>
          </a:p>
        </p:txBody>
      </p:sp>
      <p:pic>
        <p:nvPicPr>
          <p:cNvPr id="8" name="Picture 7" descr="A chart of a graph&#10;&#10;Description automatically generated with medium confidence">
            <a:extLst>
              <a:ext uri="{FF2B5EF4-FFF2-40B4-BE49-F238E27FC236}">
                <a16:creationId xmlns:a16="http://schemas.microsoft.com/office/drawing/2014/main" id="{51C0765D-843E-69C6-18EC-61312702DD0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8945"/>
          <a:stretch/>
        </p:blipFill>
        <p:spPr>
          <a:xfrm>
            <a:off x="3439881" y="570718"/>
            <a:ext cx="4572009" cy="5054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148762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of different colored objects&#10;&#10;Description automatically generated">
            <a:extLst>
              <a:ext uri="{FF2B5EF4-FFF2-40B4-BE49-F238E27FC236}">
                <a16:creationId xmlns:a16="http://schemas.microsoft.com/office/drawing/2014/main" id="{EFF75BA1-6476-2A69-A602-000C8934211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68" t="9428" r="9005"/>
          <a:stretch/>
        </p:blipFill>
        <p:spPr>
          <a:xfrm>
            <a:off x="1267097" y="398416"/>
            <a:ext cx="9065623" cy="621138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91111C32-FE21-5AD3-CC43-CB3DDFC5E28F}"/>
              </a:ext>
            </a:extLst>
          </p:cNvPr>
          <p:cNvSpPr txBox="1"/>
          <p:nvPr/>
        </p:nvSpPr>
        <p:spPr>
          <a:xfrm>
            <a:off x="3502634" y="213750"/>
            <a:ext cx="609708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rgbClr val="0070C0"/>
                </a:solidFill>
                <a:effectLst/>
                <a:highlight>
                  <a:srgbClr val="FFFFFF"/>
                </a:highlight>
                <a:latin typeface="PT Serif" panose="020A06030405050202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Cu concentration in area density (µg/cm</a:t>
            </a:r>
            <a:r>
              <a:rPr lang="en-US" sz="1800" baseline="30000" dirty="0">
                <a:solidFill>
                  <a:srgbClr val="0070C0"/>
                </a:solidFill>
                <a:effectLst/>
                <a:highlight>
                  <a:srgbClr val="FFFFFF"/>
                </a:highlight>
                <a:latin typeface="PT Serif" panose="020A06030405050202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2</a:t>
            </a:r>
            <a:r>
              <a:rPr lang="en-US" sz="1800" dirty="0">
                <a:solidFill>
                  <a:srgbClr val="0070C0"/>
                </a:solidFill>
                <a:effectLst/>
                <a:highlight>
                  <a:srgbClr val="FFFFFF"/>
                </a:highlight>
                <a:latin typeface="PT Serif" panose="020A06030405050202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6107377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hart of a graph&#10;&#10;Description automatically generated with medium confidence">
            <a:extLst>
              <a:ext uri="{FF2B5EF4-FFF2-40B4-BE49-F238E27FC236}">
                <a16:creationId xmlns:a16="http://schemas.microsoft.com/office/drawing/2014/main" id="{948EC00E-40AB-5184-3EBE-C255C49C33C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615"/>
          <a:stretch/>
        </p:blipFill>
        <p:spPr>
          <a:xfrm>
            <a:off x="6096000" y="1710612"/>
            <a:ext cx="4572009" cy="4086678"/>
          </a:xfrm>
          <a:prstGeom prst="rect">
            <a:avLst/>
          </a:prstGeom>
        </p:spPr>
      </p:pic>
      <p:pic>
        <p:nvPicPr>
          <p:cNvPr id="7" name="Picture 6" descr="A chart of a graph&#10;&#10;Description automatically generated with medium confidence">
            <a:extLst>
              <a:ext uri="{FF2B5EF4-FFF2-40B4-BE49-F238E27FC236}">
                <a16:creationId xmlns:a16="http://schemas.microsoft.com/office/drawing/2014/main" id="{5DA54A7E-E8EC-F5D8-8D2C-86E49CC4FAF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615"/>
          <a:stretch/>
        </p:blipFill>
        <p:spPr>
          <a:xfrm>
            <a:off x="1523991" y="1710612"/>
            <a:ext cx="4572009" cy="408667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E8D0080B-CC0C-3861-9947-4960F94B46A8}"/>
              </a:ext>
            </a:extLst>
          </p:cNvPr>
          <p:cNvSpPr txBox="1"/>
          <p:nvPr/>
        </p:nvSpPr>
        <p:spPr>
          <a:xfrm>
            <a:off x="2162153" y="1554922"/>
            <a:ext cx="5124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Dabi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4A67EE4-6B35-F8A9-ABA1-3AC4C4E64DC6}"/>
              </a:ext>
            </a:extLst>
          </p:cNvPr>
          <p:cNvSpPr txBox="1"/>
          <p:nvPr/>
        </p:nvSpPr>
        <p:spPr>
          <a:xfrm>
            <a:off x="2627779" y="1554920"/>
            <a:ext cx="7464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442115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9C80CC4-23D9-0BD8-D2DC-05FC942AB89C}"/>
              </a:ext>
            </a:extLst>
          </p:cNvPr>
          <p:cNvSpPr txBox="1"/>
          <p:nvPr/>
        </p:nvSpPr>
        <p:spPr>
          <a:xfrm>
            <a:off x="3327398" y="1554921"/>
            <a:ext cx="7301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494293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55192D8-61B7-BA72-6106-648B6C72C4E4}"/>
              </a:ext>
            </a:extLst>
          </p:cNvPr>
          <p:cNvSpPr txBox="1"/>
          <p:nvPr/>
        </p:nvSpPr>
        <p:spPr>
          <a:xfrm>
            <a:off x="4098097" y="1554921"/>
            <a:ext cx="7315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524446</a:t>
            </a:r>
          </a:p>
        </p:txBody>
      </p:sp>
      <p:pic>
        <p:nvPicPr>
          <p:cNvPr id="8" name="Picture 7" descr="A chart of a graph&#10;&#10;Description automatically generated with medium confidence">
            <a:extLst>
              <a:ext uri="{FF2B5EF4-FFF2-40B4-BE49-F238E27FC236}">
                <a16:creationId xmlns:a16="http://schemas.microsoft.com/office/drawing/2014/main" id="{06314B73-1579-BDC8-4140-44396618DD1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8945"/>
          <a:stretch/>
        </p:blipFill>
        <p:spPr>
          <a:xfrm>
            <a:off x="1169432" y="732449"/>
            <a:ext cx="4572009" cy="505413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C3D00546-BB8F-DB15-DAE7-AFCC3D1F543F}"/>
              </a:ext>
            </a:extLst>
          </p:cNvPr>
          <p:cNvSpPr txBox="1"/>
          <p:nvPr/>
        </p:nvSpPr>
        <p:spPr>
          <a:xfrm>
            <a:off x="6652953" y="1554922"/>
            <a:ext cx="5124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Dabi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7221D39-C182-D73F-F656-B54352115FA0}"/>
              </a:ext>
            </a:extLst>
          </p:cNvPr>
          <p:cNvSpPr txBox="1"/>
          <p:nvPr/>
        </p:nvSpPr>
        <p:spPr>
          <a:xfrm>
            <a:off x="7118579" y="1554920"/>
            <a:ext cx="7464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442115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CE12699-D2A8-DC22-D453-F224674DBFC5}"/>
              </a:ext>
            </a:extLst>
          </p:cNvPr>
          <p:cNvSpPr txBox="1"/>
          <p:nvPr/>
        </p:nvSpPr>
        <p:spPr>
          <a:xfrm>
            <a:off x="7818198" y="1554921"/>
            <a:ext cx="7301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494293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265FC54-9091-2B1C-6FEE-12AD8B73C1B7}"/>
              </a:ext>
            </a:extLst>
          </p:cNvPr>
          <p:cNvSpPr txBox="1"/>
          <p:nvPr/>
        </p:nvSpPr>
        <p:spPr>
          <a:xfrm>
            <a:off x="8588897" y="1554921"/>
            <a:ext cx="7315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524446</a:t>
            </a:r>
          </a:p>
        </p:txBody>
      </p:sp>
      <p:pic>
        <p:nvPicPr>
          <p:cNvPr id="13" name="Picture 12" descr="A chart of a graph&#10;&#10;Description automatically generated with medium confidence">
            <a:extLst>
              <a:ext uri="{FF2B5EF4-FFF2-40B4-BE49-F238E27FC236}">
                <a16:creationId xmlns:a16="http://schemas.microsoft.com/office/drawing/2014/main" id="{36BF8338-044F-DC08-942B-841BE5A1A42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8945"/>
          <a:stretch/>
        </p:blipFill>
        <p:spPr>
          <a:xfrm>
            <a:off x="5660232" y="732449"/>
            <a:ext cx="4572009" cy="5054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60494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" name="Picture 31">
            <a:extLst>
              <a:ext uri="{FF2B5EF4-FFF2-40B4-BE49-F238E27FC236}">
                <a16:creationId xmlns:a16="http://schemas.microsoft.com/office/drawing/2014/main" id="{00589B67-ED06-3B4E-CE15-16DE23BC108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190"/>
          <a:stretch/>
        </p:blipFill>
        <p:spPr>
          <a:xfrm>
            <a:off x="3809995" y="1654630"/>
            <a:ext cx="4572009" cy="4060374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ADAEBEB-FF1A-79E3-7285-F9601CC58C30}"/>
              </a:ext>
            </a:extLst>
          </p:cNvPr>
          <p:cNvSpPr txBox="1"/>
          <p:nvPr/>
        </p:nvSpPr>
        <p:spPr>
          <a:xfrm>
            <a:off x="4426381" y="1480278"/>
            <a:ext cx="5124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Dabi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8D90E1A-727F-2F77-E2A4-129C7DC86078}"/>
              </a:ext>
            </a:extLst>
          </p:cNvPr>
          <p:cNvSpPr txBox="1"/>
          <p:nvPr/>
        </p:nvSpPr>
        <p:spPr>
          <a:xfrm>
            <a:off x="4892007" y="1480276"/>
            <a:ext cx="7464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442115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F399C20-2FCE-E1D6-FEFA-0922FF45B72C}"/>
              </a:ext>
            </a:extLst>
          </p:cNvPr>
          <p:cNvSpPr txBox="1"/>
          <p:nvPr/>
        </p:nvSpPr>
        <p:spPr>
          <a:xfrm>
            <a:off x="5591626" y="1480277"/>
            <a:ext cx="7301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494293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9DF38CB-A673-1CC1-7BD4-BEA2385BB136}"/>
              </a:ext>
            </a:extLst>
          </p:cNvPr>
          <p:cNvSpPr txBox="1"/>
          <p:nvPr/>
        </p:nvSpPr>
        <p:spPr>
          <a:xfrm>
            <a:off x="6362325" y="1480277"/>
            <a:ext cx="7315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524446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F58C1CA2-3A0E-55C4-CB4A-11E9B07C23D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8809"/>
          <a:stretch/>
        </p:blipFill>
        <p:spPr>
          <a:xfrm>
            <a:off x="3595390" y="800002"/>
            <a:ext cx="4572009" cy="5116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6645511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of different colored objects&#10;&#10;Description automatically generated">
            <a:extLst>
              <a:ext uri="{FF2B5EF4-FFF2-40B4-BE49-F238E27FC236}">
                <a16:creationId xmlns:a16="http://schemas.microsoft.com/office/drawing/2014/main" id="{C3550D2D-74B5-3145-A915-4AA1961D9D6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76" t="9524" r="9259"/>
          <a:stretch/>
        </p:blipFill>
        <p:spPr>
          <a:xfrm>
            <a:off x="1724297" y="502919"/>
            <a:ext cx="8987246" cy="620485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59D44AE5-050F-4833-13CE-61A64BC3B5C9}"/>
              </a:ext>
            </a:extLst>
          </p:cNvPr>
          <p:cNvSpPr txBox="1"/>
          <p:nvPr/>
        </p:nvSpPr>
        <p:spPr>
          <a:xfrm>
            <a:off x="3378225" y="308302"/>
            <a:ext cx="609708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solidFill>
                  <a:srgbClr val="0070C0"/>
                </a:solidFill>
                <a:effectLst/>
                <a:highlight>
                  <a:srgbClr val="FFFFFF"/>
                </a:highlight>
                <a:latin typeface="PT Serif" panose="020A06030405050202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Zn concentration in area density (µg/cm</a:t>
            </a:r>
            <a:r>
              <a:rPr lang="en-US" sz="1800" baseline="30000" dirty="0">
                <a:solidFill>
                  <a:srgbClr val="0070C0"/>
                </a:solidFill>
                <a:effectLst/>
                <a:highlight>
                  <a:srgbClr val="FFFFFF"/>
                </a:highlight>
                <a:latin typeface="PT Serif" panose="020A06030405050202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2</a:t>
            </a:r>
            <a:r>
              <a:rPr lang="en-US" sz="1800" dirty="0">
                <a:solidFill>
                  <a:srgbClr val="0070C0"/>
                </a:solidFill>
                <a:effectLst/>
                <a:highlight>
                  <a:srgbClr val="FFFFFF"/>
                </a:highlight>
                <a:latin typeface="PT Serif" panose="020A06030405050202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5207962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" name="Picture 33">
            <a:extLst>
              <a:ext uri="{FF2B5EF4-FFF2-40B4-BE49-F238E27FC236}">
                <a16:creationId xmlns:a16="http://schemas.microsoft.com/office/drawing/2014/main" id="{BBC6B6FC-CD81-D3FA-C7A2-0C5E4254C3E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939"/>
          <a:stretch/>
        </p:blipFill>
        <p:spPr>
          <a:xfrm>
            <a:off x="6096000" y="1710612"/>
            <a:ext cx="4572009" cy="4071888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BDF6EABC-B504-AD0C-0794-5D414F561D9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939"/>
          <a:stretch/>
        </p:blipFill>
        <p:spPr>
          <a:xfrm>
            <a:off x="1523991" y="1710612"/>
            <a:ext cx="4572009" cy="407188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FABABB7-5830-AE82-CC77-E72CA299BD09}"/>
              </a:ext>
            </a:extLst>
          </p:cNvPr>
          <p:cNvSpPr txBox="1"/>
          <p:nvPr/>
        </p:nvSpPr>
        <p:spPr>
          <a:xfrm>
            <a:off x="2143491" y="1548703"/>
            <a:ext cx="5124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Dabi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2F26FB7-ECE6-913A-BDEF-39376684269E}"/>
              </a:ext>
            </a:extLst>
          </p:cNvPr>
          <p:cNvSpPr txBox="1"/>
          <p:nvPr/>
        </p:nvSpPr>
        <p:spPr>
          <a:xfrm>
            <a:off x="2609117" y="1548701"/>
            <a:ext cx="7464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442115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2F569E2-40A5-50AF-5031-DC2734F7FB93}"/>
              </a:ext>
            </a:extLst>
          </p:cNvPr>
          <p:cNvSpPr txBox="1"/>
          <p:nvPr/>
        </p:nvSpPr>
        <p:spPr>
          <a:xfrm>
            <a:off x="3308736" y="1548702"/>
            <a:ext cx="7301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494293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1AAFA20-6DAD-591B-905E-D41B9DC4375A}"/>
              </a:ext>
            </a:extLst>
          </p:cNvPr>
          <p:cNvSpPr txBox="1"/>
          <p:nvPr/>
        </p:nvSpPr>
        <p:spPr>
          <a:xfrm>
            <a:off x="4079435" y="1548702"/>
            <a:ext cx="7315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524446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60D460B0-1EE2-6253-08D5-5906D483676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8809"/>
          <a:stretch/>
        </p:blipFill>
        <p:spPr>
          <a:xfrm>
            <a:off x="1312500" y="868427"/>
            <a:ext cx="4572009" cy="511634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60A207BE-E40B-7309-A8CB-C2B526EB78BE}"/>
              </a:ext>
            </a:extLst>
          </p:cNvPr>
          <p:cNvSpPr txBox="1"/>
          <p:nvPr/>
        </p:nvSpPr>
        <p:spPr>
          <a:xfrm>
            <a:off x="6698109" y="1506547"/>
            <a:ext cx="5124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Dabi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248E9C3-3A92-ED3A-7E38-48EBFA78901B}"/>
              </a:ext>
            </a:extLst>
          </p:cNvPr>
          <p:cNvSpPr txBox="1"/>
          <p:nvPr/>
        </p:nvSpPr>
        <p:spPr>
          <a:xfrm>
            <a:off x="7163735" y="1506545"/>
            <a:ext cx="7464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442115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10845CA-2287-AFD7-A194-D5A898AE3C18}"/>
              </a:ext>
            </a:extLst>
          </p:cNvPr>
          <p:cNvSpPr txBox="1"/>
          <p:nvPr/>
        </p:nvSpPr>
        <p:spPr>
          <a:xfrm>
            <a:off x="7863354" y="1506546"/>
            <a:ext cx="7301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494293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66F7930-FD13-45DB-0FE8-58FFF38E9EA1}"/>
              </a:ext>
            </a:extLst>
          </p:cNvPr>
          <p:cNvSpPr txBox="1"/>
          <p:nvPr/>
        </p:nvSpPr>
        <p:spPr>
          <a:xfrm>
            <a:off x="8634053" y="1506546"/>
            <a:ext cx="7315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PI524446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9635D424-B90D-0A9B-38FC-28B95E1BE2E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8809"/>
          <a:stretch/>
        </p:blipFill>
        <p:spPr>
          <a:xfrm>
            <a:off x="5867118" y="826271"/>
            <a:ext cx="4572009" cy="5116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39363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a2761ec8-7198-4440-bea0-e9dd2af28b51}" enabled="1" method="Standard" siteId="{73e15cf5-5dbb-46af-a862-753916269d73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69</TotalTime>
  <Words>167</Words>
  <Application>Microsoft Office PowerPoint</Application>
  <PresentationFormat>Widescreen</PresentationFormat>
  <Paragraphs>88</Paragraphs>
  <Slides>1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8</vt:i4>
      </vt:variant>
    </vt:vector>
  </HeadingPairs>
  <TitlesOfParts>
    <vt:vector size="23" baseType="lpstr">
      <vt:lpstr>Aptos</vt:lpstr>
      <vt:lpstr>Aptos Display</vt:lpstr>
      <vt:lpstr>Arial</vt:lpstr>
      <vt:lpstr>PT Serif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ric Whisnant</dc:creator>
  <cp:lastModifiedBy>Ayalew Osena</cp:lastModifiedBy>
  <cp:revision>3</cp:revision>
  <dcterms:created xsi:type="dcterms:W3CDTF">2024-06-18T19:11:05Z</dcterms:created>
  <dcterms:modified xsi:type="dcterms:W3CDTF">2024-08-13T13:37:09Z</dcterms:modified>
</cp:coreProperties>
</file>